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58" r:id="rId3"/>
    <p:sldId id="259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807"/>
  </p:normalViewPr>
  <p:slideViewPr>
    <p:cSldViewPr snapToGrid="0">
      <p:cViewPr varScale="1">
        <p:scale>
          <a:sx n="58" d="100"/>
          <a:sy n="58" d="100"/>
        </p:scale>
        <p:origin x="197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MX"/>
              <a:t>Haz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6991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0873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37089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60127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31251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51628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10677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60970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99510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31517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MX"/>
              <a:t>Haz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1158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DE9F89-E524-334F-8372-EC504EF5DE9C}" type="datetimeFigureOut">
              <a:rPr lang="es-MX" smtClean="0"/>
              <a:t>06/09/2024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0CD7A-CDEF-AE48-988A-929D3589553D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212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6A6F3D-0AF5-E721-4608-838AF61B5E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1679005"/>
            <a:ext cx="5915025" cy="2817679"/>
          </a:xfrm>
        </p:spPr>
        <p:txBody>
          <a:bodyPr>
            <a:norm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asma inflammatory proteome profile in a cohort of RVVC patients in Kenya</a:t>
            </a: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iletta Rosati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#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Isis Ricano Ponce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,#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Gloria S. Omosa-Manyonyi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,#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Mariolina Bruno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elly W. Kamau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2</a:t>
            </a:r>
            <a: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artin Jaeger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Vinod Kumar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,3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Mihai G. Netea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,4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Andre J.A.M. van der Ven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Jaap ten Oever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GB" dirty="0"/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F09DD49C-B6BC-9E89-31A2-85133758B6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8" y="4953000"/>
            <a:ext cx="5915025" cy="3969280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Supplementary Figures Fi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14717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CC6CD1-C8D2-F936-91E1-9145138A66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53453" y="6079904"/>
            <a:ext cx="5408450" cy="969079"/>
          </a:xfrm>
        </p:spPr>
        <p:txBody>
          <a:bodyPr>
            <a:normAutofit/>
          </a:bodyPr>
          <a:lstStyle/>
          <a:p>
            <a:pPr algn="l"/>
            <a:r>
              <a:rPr lang="en-GB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S1. </a:t>
            </a:r>
            <a: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rincipal component analysis (PCA) depicting the sample distribution between the two batches.</a:t>
            </a:r>
            <a:endParaRPr lang="en-GB" sz="1800" dirty="0"/>
          </a:p>
        </p:txBody>
      </p:sp>
      <p:pic>
        <p:nvPicPr>
          <p:cNvPr id="5" name="Content Placeholder 4" descr="A graph with green and red dots&#10;&#10;Description automatically generated">
            <a:extLst>
              <a:ext uri="{FF2B5EF4-FFF2-40B4-BE49-F238E27FC236}">
                <a16:creationId xmlns:a16="http://schemas.microsoft.com/office/drawing/2014/main" id="{7F97EBEA-8C47-90B9-61B0-84204D5362B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71487" y="527405"/>
            <a:ext cx="5408451" cy="5668245"/>
          </a:xfrm>
        </p:spPr>
      </p:pic>
    </p:spTree>
    <p:extLst>
      <p:ext uri="{BB962C8B-B14F-4D97-AF65-F5344CB8AC3E}">
        <p14:creationId xmlns:p14="http://schemas.microsoft.com/office/powerpoint/2010/main" val="28473165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A2944-6699-B8ED-9F86-7B5E2C583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5109" y="5631840"/>
            <a:ext cx="5915025" cy="1914702"/>
          </a:xfrm>
        </p:spPr>
        <p:txBody>
          <a:bodyPr>
            <a:normAutofit/>
          </a:bodyPr>
          <a:lstStyle/>
          <a:p>
            <a:r>
              <a:rPr lang="en-GB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S2. </a:t>
            </a:r>
            <a: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Principal component analysis (PCA) of samples distribution between women with RVVC and controls.</a:t>
            </a:r>
            <a:endParaRPr lang="en-GB" sz="1800" dirty="0"/>
          </a:p>
        </p:txBody>
      </p:sp>
      <p:pic>
        <p:nvPicPr>
          <p:cNvPr id="5" name="Content Placeholder 4" descr="A graph with a pink circle and blue circle&#10;&#10;Description automatically generated with medium confidence">
            <a:extLst>
              <a:ext uri="{FF2B5EF4-FFF2-40B4-BE49-F238E27FC236}">
                <a16:creationId xmlns:a16="http://schemas.microsoft.com/office/drawing/2014/main" id="{0A50B7ED-9771-98E7-1E03-066C524B9FE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71487" y="569240"/>
            <a:ext cx="5915025" cy="5257800"/>
          </a:xfrm>
        </p:spPr>
      </p:pic>
    </p:spTree>
    <p:extLst>
      <p:ext uri="{BB962C8B-B14F-4D97-AF65-F5344CB8AC3E}">
        <p14:creationId xmlns:p14="http://schemas.microsoft.com/office/powerpoint/2010/main" val="2315711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A2944-6699-B8ED-9F86-7B5E2C583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84725" y="4953000"/>
            <a:ext cx="5915025" cy="1914702"/>
          </a:xfrm>
        </p:spPr>
        <p:txBody>
          <a:bodyPr>
            <a:normAutofit fontScale="90000"/>
          </a:bodyPr>
          <a:lstStyle/>
          <a:p>
            <a:pPr algn="just"/>
            <a:r>
              <a:rPr lang="en-GB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S3. </a:t>
            </a:r>
            <a: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VVC patients compared with controls correcting for contraceptive use and co-infections status. A. After correcting for multiple testing B. Without correcting for multiple testing. The X axis represents the logarithm of the fold change </a:t>
            </a:r>
            <a:b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</a:br>
            <a: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Log FC) of RVVC patients compared with controls and the Y axis represents the negative logarithm base 10 of the adjusted P value (</a:t>
            </a:r>
            <a:r>
              <a:rPr lang="en-GB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dj.P.Val</a:t>
            </a:r>
            <a: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) and the P value.</a:t>
            </a:r>
            <a:endParaRPr lang="en-GB" sz="1800" dirty="0"/>
          </a:p>
        </p:txBody>
      </p:sp>
      <p:pic>
        <p:nvPicPr>
          <p:cNvPr id="11" name="Picture 10" descr="A graph of a function&#10;&#10;Description automatically generated with medium confidence">
            <a:extLst>
              <a:ext uri="{FF2B5EF4-FFF2-40B4-BE49-F238E27FC236}">
                <a16:creationId xmlns:a16="http://schemas.microsoft.com/office/drawing/2014/main" id="{3223DDDF-B6DA-C8AD-51D2-4FD6A70B5A3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303" t="10433" r="8938" b="26758"/>
          <a:stretch/>
        </p:blipFill>
        <p:spPr>
          <a:xfrm>
            <a:off x="51758" y="840712"/>
            <a:ext cx="6754484" cy="40112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20351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84</Words>
  <Application>Microsoft Office PowerPoint</Application>
  <PresentationFormat>A4 Paper (210x297 mm)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Plasma inflammatory proteome profile in a cohort of RVVC patients in Kenya   Diletta Rosati1#, Isis Ricano Ponce1,#, Gloria S. Omosa-Manyonyi2,#, Mariolina Bruno1, Nelly W. Kamau2,  Martin Jaeger1, Vinod Kumar1,3, Mihai G. Netea1,4, Andre J.A.M. van der Ven1, Jaap ten Oever1. </vt:lpstr>
      <vt:lpstr>Supplementary Figure S1. Principal component analysis (PCA) depicting the sample distribution between the two batches.</vt:lpstr>
      <vt:lpstr>Supplementary Figure S2.  Principal component analysis (PCA) of samples distribution between women with RVVC and controls.</vt:lpstr>
      <vt:lpstr>Supplementary Figure S3. RVVC patients compared with controls correcting for contraceptive use and co-infections status. A. After correcting for multiple testing B. Without correcting for multiple testing. The X axis represents the logarithm of the fold change  (Log FC) of RVVC patients compared with controls and the Y axis represents the negative logarithm base 10 of the adjusted P value (adj.P.Val) and the P value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sis Ricano Ponce</dc:creator>
  <cp:lastModifiedBy>MDPI</cp:lastModifiedBy>
  <cp:revision>7</cp:revision>
  <dcterms:created xsi:type="dcterms:W3CDTF">2024-06-05T03:52:39Z</dcterms:created>
  <dcterms:modified xsi:type="dcterms:W3CDTF">2024-09-06T04:09:12Z</dcterms:modified>
</cp:coreProperties>
</file>